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2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800"/>
    <a:srgbClr val="FFFFC8"/>
    <a:srgbClr val="FFDC00"/>
    <a:srgbClr val="FFFF64"/>
    <a:srgbClr val="00FF00"/>
    <a:srgbClr val="FFC8FF"/>
    <a:srgbClr val="64FFFF"/>
    <a:srgbClr val="C8FFFF"/>
    <a:srgbClr val="FF00FF"/>
    <a:srgbClr val="CC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13" autoAdjust="0"/>
    <p:restoredTop sz="94746"/>
  </p:normalViewPr>
  <p:slideViewPr>
    <p:cSldViewPr snapToGrid="0" snapToObjects="1">
      <p:cViewPr varScale="1">
        <p:scale>
          <a:sx n="124" d="100"/>
          <a:sy n="124" d="100"/>
        </p:scale>
        <p:origin x="1400" y="16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5" d="100"/>
        <a:sy n="11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55A03B-9FEF-EA4F-A227-0F577A9CB87C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4C5DBC-334D-324B-8458-5D5051B0CC2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686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2013</a:t>
            </a:r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912461-9941-4E85-B547-8F4D86D850E8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83004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5700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1991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709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5715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4014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184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070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033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7421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775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64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93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327C2EBC-8902-A6EE-ED91-23E4D4B564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858" t="58768" r="57304" b="30897"/>
          <a:stretch/>
        </p:blipFill>
        <p:spPr>
          <a:xfrm>
            <a:off x="1244842" y="1691544"/>
            <a:ext cx="2562339" cy="53914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E9131125-B789-60FB-313E-814E20877D3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076" t="64299" r="54561" b="25218"/>
          <a:stretch/>
        </p:blipFill>
        <p:spPr>
          <a:xfrm>
            <a:off x="1244842" y="391972"/>
            <a:ext cx="2562340" cy="53914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617996C-10F2-7E3F-ECE4-27A313C81615}"/>
              </a:ext>
            </a:extLst>
          </p:cNvPr>
          <p:cNvSpPr txBox="1"/>
          <p:nvPr/>
        </p:nvSpPr>
        <p:spPr>
          <a:xfrm>
            <a:off x="1483071" y="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A649ACF-1891-995E-5DD1-91FB642F0108}"/>
              </a:ext>
            </a:extLst>
          </p:cNvPr>
          <p:cNvSpPr txBox="1"/>
          <p:nvPr/>
        </p:nvSpPr>
        <p:spPr>
          <a:xfrm>
            <a:off x="2148078" y="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2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CF56956-612E-3DCC-19CE-0642834D51E7}"/>
              </a:ext>
            </a:extLst>
          </p:cNvPr>
          <p:cNvSpPr txBox="1"/>
          <p:nvPr/>
        </p:nvSpPr>
        <p:spPr>
          <a:xfrm>
            <a:off x="2813085" y="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3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10B42B3-440D-F27C-97AB-B9AEFA3BAFF0}"/>
              </a:ext>
            </a:extLst>
          </p:cNvPr>
          <p:cNvSpPr txBox="1"/>
          <p:nvPr/>
        </p:nvSpPr>
        <p:spPr>
          <a:xfrm>
            <a:off x="3204131" y="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WT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A32F3A2-B512-02CA-2A6D-BBB3C73DFF89}"/>
              </a:ext>
            </a:extLst>
          </p:cNvPr>
          <p:cNvSpPr txBox="1"/>
          <p:nvPr/>
        </p:nvSpPr>
        <p:spPr>
          <a:xfrm>
            <a:off x="-72013" y="720547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IP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66AE536-97DA-4DF6-07B5-4FE6DA73AF5D}"/>
              </a:ext>
            </a:extLst>
          </p:cNvPr>
          <p:cNvSpPr txBox="1"/>
          <p:nvPr/>
        </p:nvSpPr>
        <p:spPr>
          <a:xfrm>
            <a:off x="-72013" y="2023684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Actin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3A25E2A-949A-0C7C-7044-E024CC4C845E}"/>
              </a:ext>
            </a:extLst>
          </p:cNvPr>
          <p:cNvSpPr txBox="1"/>
          <p:nvPr/>
        </p:nvSpPr>
        <p:spPr>
          <a:xfrm>
            <a:off x="567974" y="430710"/>
            <a:ext cx="683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RT +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02ED098-8831-5D50-55F5-6C1842F74F66}"/>
              </a:ext>
            </a:extLst>
          </p:cNvPr>
          <p:cNvSpPr txBox="1"/>
          <p:nvPr/>
        </p:nvSpPr>
        <p:spPr>
          <a:xfrm>
            <a:off x="567974" y="1008669"/>
            <a:ext cx="62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RT -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CC4E3FC7-9194-86CE-0445-9DA40B97960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7681" t="63874" r="14956" b="25711"/>
          <a:stretch/>
        </p:blipFill>
        <p:spPr>
          <a:xfrm>
            <a:off x="1244842" y="971647"/>
            <a:ext cx="2562339" cy="535709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82DED9B-637D-1FB3-EBE4-B8F923D61FDF}"/>
              </a:ext>
            </a:extLst>
          </p:cNvPr>
          <p:cNvSpPr txBox="1"/>
          <p:nvPr/>
        </p:nvSpPr>
        <p:spPr>
          <a:xfrm>
            <a:off x="567974" y="1730282"/>
            <a:ext cx="683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RT +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F60F0F1-E306-38FE-077C-784A396E14DE}"/>
              </a:ext>
            </a:extLst>
          </p:cNvPr>
          <p:cNvSpPr txBox="1"/>
          <p:nvPr/>
        </p:nvSpPr>
        <p:spPr>
          <a:xfrm>
            <a:off x="567974" y="2317087"/>
            <a:ext cx="62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RT -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E6046501-CDF9-157E-FAC1-9DF8EDF8799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5046" t="58768" r="18116" b="30897"/>
          <a:stretch/>
        </p:blipFill>
        <p:spPr>
          <a:xfrm>
            <a:off x="1244842" y="2278349"/>
            <a:ext cx="2562339" cy="539140"/>
          </a:xfrm>
          <a:prstGeom prst="rect">
            <a:avLst/>
          </a:prstGeom>
        </p:spPr>
      </p:pic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2F601D8-9D4C-ED66-178F-D9E92543BFD6}"/>
              </a:ext>
            </a:extLst>
          </p:cNvPr>
          <p:cNvCxnSpPr>
            <a:cxnSpLocks/>
          </p:cNvCxnSpPr>
          <p:nvPr/>
        </p:nvCxnSpPr>
        <p:spPr>
          <a:xfrm>
            <a:off x="1351524" y="336555"/>
            <a:ext cx="57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E83806A8-6270-1F45-0E56-92F03675FE76}"/>
              </a:ext>
            </a:extLst>
          </p:cNvPr>
          <p:cNvCxnSpPr>
            <a:cxnSpLocks/>
          </p:cNvCxnSpPr>
          <p:nvPr/>
        </p:nvCxnSpPr>
        <p:spPr>
          <a:xfrm>
            <a:off x="2016531" y="336555"/>
            <a:ext cx="57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27908698-81F2-D992-0155-564A838CF0D8}"/>
              </a:ext>
            </a:extLst>
          </p:cNvPr>
          <p:cNvCxnSpPr>
            <a:cxnSpLocks/>
          </p:cNvCxnSpPr>
          <p:nvPr/>
        </p:nvCxnSpPr>
        <p:spPr>
          <a:xfrm>
            <a:off x="2681538" y="336555"/>
            <a:ext cx="57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4C90583-C43A-8FB4-77D1-AFD7E6EAD6B1}"/>
              </a:ext>
            </a:extLst>
          </p:cNvPr>
          <p:cNvSpPr txBox="1"/>
          <p:nvPr/>
        </p:nvSpPr>
        <p:spPr>
          <a:xfrm>
            <a:off x="4146000" y="0"/>
            <a:ext cx="57600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b="1" kern="0" dirty="0">
                <a:effectLst/>
                <a:highlight>
                  <a:srgbClr val="FCFCFC"/>
                </a:highlight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Online </a:t>
            </a:r>
            <a:r>
              <a:rPr lang="en-US" altLang="ja-JP" b="1" kern="0">
                <a:effectLst/>
                <a:highlight>
                  <a:srgbClr val="FCFCFC"/>
                </a:highlight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esource</a:t>
            </a:r>
            <a:r>
              <a:rPr lang="en-US" altLang="ja-JP" b="1" kern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6</a:t>
            </a:r>
            <a:r>
              <a:rPr lang="ja-JP" altLang="ja-JP" b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</a:t>
            </a:r>
            <a:r>
              <a:rPr lang="en-US" altLang="ja-JP" i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r>
              <a:rPr lang="en-US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in transgenic rice</a:t>
            </a:r>
          </a:p>
          <a:p>
            <a:pPr algn="just"/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RT-PCR was performed using </a:t>
            </a:r>
            <a:r>
              <a:rPr lang="en-US" altLang="ja-JP" sz="1800" i="1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specific primers (P1-F1 and PI-R2, Table 1) or actin-specific primers (RAc-1 and RAc-2, Table 1). Two </a:t>
            </a:r>
            <a:r>
              <a:rPr lang="en-US" altLang="ja-JP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dependent RNA samples were used for each of three transgenic plants.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RT+ indicates that reverse transcriptase was added to the reverse transcription reaction mixture, and RT- indicates that reverse transcriptase was omitted from the reaction mixture. Actin was used as an internal control. WT: wild type plant.</a:t>
            </a:r>
            <a:endParaRPr lang="ja-JP" altLang="ja-JP" sz="18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53693757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50</TotalTime>
  <Words>105</Words>
  <Application>Microsoft Macintosh PowerPoint</Application>
  <PresentationFormat>A4 210 x 297 mm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Yu Gothic</vt:lpstr>
      <vt:lpstr>Arial</vt:lpstr>
      <vt:lpstr>Calibri</vt:lpstr>
      <vt:lpstr>Calibri Light</vt:lpstr>
      <vt:lpstr>Helvetica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伊藤 幸博</cp:lastModifiedBy>
  <cp:revision>484</cp:revision>
  <dcterms:created xsi:type="dcterms:W3CDTF">2019-07-05T07:37:37Z</dcterms:created>
  <dcterms:modified xsi:type="dcterms:W3CDTF">2025-06-13T00:46:21Z</dcterms:modified>
</cp:coreProperties>
</file>